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417"/>
    <p:restoredTop sz="94541"/>
  </p:normalViewPr>
  <p:slideViewPr>
    <p:cSldViewPr snapToGrid="0" snapToObjects="1">
      <p:cViewPr varScale="1">
        <p:scale>
          <a:sx n="124" d="100"/>
          <a:sy n="124" d="100"/>
        </p:scale>
        <p:origin x="776" y="16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9BC341-B0E8-554C-888B-3252B3AB75C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440B327-93FA-A742-9A0A-881EBF87A27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5DE251-8AC3-CF48-A39F-FB0F4E7398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6AE8EE-384D-D84E-8313-B0371CA5EAD2}" type="datetimeFigureOut">
              <a:rPr lang="en-US" smtClean="0"/>
              <a:pPr/>
              <a:t>10/3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14DE8F-57D3-5044-A7C7-43D7A72E3F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46E1A7-C2FF-D64D-8F68-73E0BE97A7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3DE2D7-A1BD-BD4E-AF66-1635FDF808D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01858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7A758B-48E7-9140-B7E3-BC866C8965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54BCEB8-C75A-6745-94B3-F0FA6B94911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F1DF0B-10A9-3C4E-BE5C-ED144EDC54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6AE8EE-384D-D84E-8313-B0371CA5EAD2}" type="datetimeFigureOut">
              <a:rPr lang="en-US" smtClean="0"/>
              <a:pPr/>
              <a:t>10/3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C3322A-C63B-F245-A7C0-415DFD0074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F925B0-FC8D-D546-A8B7-7067101483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3DE2D7-A1BD-BD4E-AF66-1635FDF808D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69871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37704E7-88FE-DD47-A99D-4E54CABF874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BFCBB0E-6425-2C4D-A850-A5DAE308A88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7893B0-0E11-134A-B59A-C536515961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6AE8EE-384D-D84E-8313-B0371CA5EAD2}" type="datetimeFigureOut">
              <a:rPr lang="en-US" smtClean="0"/>
              <a:pPr/>
              <a:t>10/3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378C9A-F564-5A49-BCC7-758322AF55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DAC181-B9DC-724D-A30C-1AE3904335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3DE2D7-A1BD-BD4E-AF66-1635FDF808D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95487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CECDE6-8E21-2144-B85B-ACAF7E5978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5182158-8A64-5E4A-839B-55F251A76F2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20F4B87-7698-9F4F-9F9A-CB22F63F1D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6AE8EE-384D-D84E-8313-B0371CA5EAD2}" type="datetimeFigureOut">
              <a:rPr lang="en-US" smtClean="0"/>
              <a:pPr/>
              <a:t>10/3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F8D756-9621-C54B-B432-89C8D3A4EC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45E459-3A60-DD4B-B52D-BD3BF5F4B5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3DE2D7-A1BD-BD4E-AF66-1635FDF808D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42715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DDC5BB-13FF-064B-B11D-EA4DFBA294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B2C3587-74ED-C142-936D-4A5538A28D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4EC16C-9D25-904F-A37D-1E12F24A6D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6AE8EE-384D-D84E-8313-B0371CA5EAD2}" type="datetimeFigureOut">
              <a:rPr lang="en-US" smtClean="0"/>
              <a:pPr/>
              <a:t>10/3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C92817-A168-C748-8EAE-F5CA481A4A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B97372-0A36-5149-AEF6-97555F9B85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3DE2D7-A1BD-BD4E-AF66-1635FDF808D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16256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6E0A05-3220-FF4D-9569-F76DD5F430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787F3A6-CC33-AF4A-BA1D-09197005269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C5DFB44-ADA9-F048-9563-481015724A9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8F99FBD-2543-0D4D-9FBD-CFA0115FCD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6AE8EE-384D-D84E-8313-B0371CA5EAD2}" type="datetimeFigureOut">
              <a:rPr lang="en-US" smtClean="0"/>
              <a:pPr/>
              <a:t>10/31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80953E5-F693-894C-A1A1-9A253968D7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B46DDE9-9F2D-4C41-B2DC-7C5959C3BE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3DE2D7-A1BD-BD4E-AF66-1635FDF808D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67592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F0D116-92ED-4144-823E-588EA52989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00C7C0E-CFE0-F444-A84D-817B57AEBA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6CB0688-8362-8C4F-980C-C5BDD1DEF49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578AA4B-9697-1541-B6D4-0D35768C99D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2E6D51B-0451-0941-A1C9-405ED4BCC37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B79A6FB-674E-D140-A18D-3D3769FB73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6AE8EE-384D-D84E-8313-B0371CA5EAD2}" type="datetimeFigureOut">
              <a:rPr lang="en-US" smtClean="0"/>
              <a:pPr/>
              <a:t>10/31/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80EA154-75A9-9F4C-A783-780D2C40C8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FE37ADA-3375-DF40-849E-5DB0000BD1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3DE2D7-A1BD-BD4E-AF66-1635FDF808D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89310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35E492-9E12-C949-B80C-C7EF8D5B21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2D303F6-E54C-2740-96DD-FD6D3485B7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6AE8EE-384D-D84E-8313-B0371CA5EAD2}" type="datetimeFigureOut">
              <a:rPr lang="en-US" smtClean="0"/>
              <a:pPr/>
              <a:t>10/31/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8CAAD54-722B-E24A-A7AD-079BB17803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3F8F09C-9E2A-D14F-B818-2B1E1AC957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3DE2D7-A1BD-BD4E-AF66-1635FDF808D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44932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E0EE5D0-648D-974A-8D1D-87261F63F0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6AE8EE-384D-D84E-8313-B0371CA5EAD2}" type="datetimeFigureOut">
              <a:rPr lang="en-US" smtClean="0"/>
              <a:pPr/>
              <a:t>10/31/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4B25579-84BC-474E-85B8-EAD8AC97DB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9BFA04F-2778-2142-9EB4-233EEB1F0F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3DE2D7-A1BD-BD4E-AF66-1635FDF808D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74691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6AD916-8D03-7F4C-B145-4E3DA9078F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4B41653-73A0-DE48-ADE9-1A86F6120F4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4F19843-5B8E-DF49-837E-D0FD99F1B1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114B9A8-2E32-B744-82A4-6C6FD97520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6AE8EE-384D-D84E-8313-B0371CA5EAD2}" type="datetimeFigureOut">
              <a:rPr lang="en-US" smtClean="0"/>
              <a:pPr/>
              <a:t>10/31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D136BD6-4DE2-D242-A9C4-641FFEE5A8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1685152-49FA-294B-B135-8B2FB05569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3DE2D7-A1BD-BD4E-AF66-1635FDF808D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65227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D70BD3-8F8F-7E49-A3A5-90B3EB61EA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B702340-E5E4-7741-AB68-668C96B85EE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5D7D98B-40BF-674A-B402-0EA9B7DA955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8DA4363-4FA3-C446-A666-3FB4560883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6AE8EE-384D-D84E-8313-B0371CA5EAD2}" type="datetimeFigureOut">
              <a:rPr lang="en-US" smtClean="0"/>
              <a:pPr/>
              <a:t>10/31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E0EAD54-8539-744B-BC91-E205078254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B2A119F-7480-544F-9E5C-C19F367D57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3DE2D7-A1BD-BD4E-AF66-1635FDF808D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53876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B476A73-813F-0C4E-8A90-553625A89C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F696871-64D0-AE49-80EB-7CB4C8AE2F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48DD87F-0A5E-4144-AE3C-C0754BEE76E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6AE8EE-384D-D84E-8313-B0371CA5EAD2}" type="datetimeFigureOut">
              <a:rPr lang="en-US" smtClean="0"/>
              <a:pPr/>
              <a:t>10/3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96617B-8115-9244-8F84-AF3F74335C8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D75B1E-EF77-A548-B7FD-514A598144D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3DE2D7-A1BD-BD4E-AF66-1635FDF808D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49446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DB43EA5B-C354-C840-820A-7B0731533970}"/>
              </a:ext>
            </a:extLst>
          </p:cNvPr>
          <p:cNvSpPr txBox="1"/>
          <p:nvPr/>
        </p:nvSpPr>
        <p:spPr>
          <a:xfrm>
            <a:off x="203954" y="4930438"/>
            <a:ext cx="11744587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" pitchFamily="2" charset="0"/>
              </a:rPr>
              <a:t>Supplementary Figure S3: </a:t>
            </a:r>
            <a:r>
              <a:rPr lang="en-US" sz="1400" dirty="0">
                <a:latin typeface="Times" pitchFamily="2" charset="0"/>
              </a:rPr>
              <a:t>Positional enrichment of known transcription factors in the promoter regions of the differentially expressed genes at T = 6 h in sorghum drought-tolerant lines (DR1 and DR2) are shown using (a</a:t>
            </a:r>
            <a:r>
              <a:rPr lang="en-US" sz="1400">
                <a:latin typeface="Times" pitchFamily="2" charset="0"/>
              </a:rPr>
              <a:t>) </a:t>
            </a:r>
            <a:r>
              <a:rPr lang="en-US" sz="1400" dirty="0">
                <a:latin typeface="Times" pitchFamily="2" charset="0"/>
              </a:rPr>
              <a:t>A</a:t>
            </a:r>
            <a:r>
              <a:rPr lang="en-US" sz="1400">
                <a:latin typeface="Times" pitchFamily="2" charset="0"/>
              </a:rPr>
              <a:t>rabidopsis </a:t>
            </a:r>
            <a:r>
              <a:rPr lang="en-US" sz="1400" dirty="0">
                <a:latin typeface="Times" pitchFamily="2" charset="0"/>
              </a:rPr>
              <a:t>TF database and (b) general eukaryote TF database. These analyses were done using the </a:t>
            </a:r>
            <a:r>
              <a:rPr lang="en-US" sz="1400" dirty="0" err="1">
                <a:latin typeface="Times" pitchFamily="2" charset="0"/>
              </a:rPr>
              <a:t>Centrimo</a:t>
            </a:r>
            <a:r>
              <a:rPr lang="en-US" sz="1400" dirty="0">
                <a:latin typeface="Times" pitchFamily="2" charset="0"/>
              </a:rPr>
              <a:t> tool from MEME suite. </a:t>
            </a:r>
            <a:endParaRPr lang="en-US" sz="1400" b="1" dirty="0">
              <a:latin typeface="Times" pitchFamily="2" charset="0"/>
            </a:endParaRPr>
          </a:p>
        </p:txBody>
      </p:sp>
      <p:grpSp>
        <p:nvGrpSpPr>
          <p:cNvPr id="37" name="Group 36">
            <a:extLst>
              <a:ext uri="{FF2B5EF4-FFF2-40B4-BE49-F238E27FC236}">
                <a16:creationId xmlns:a16="http://schemas.microsoft.com/office/drawing/2014/main" id="{D0411002-7171-1442-8421-3BB238F6C95C}"/>
              </a:ext>
            </a:extLst>
          </p:cNvPr>
          <p:cNvGrpSpPr/>
          <p:nvPr/>
        </p:nvGrpSpPr>
        <p:grpSpPr>
          <a:xfrm>
            <a:off x="222423" y="1096827"/>
            <a:ext cx="5825927" cy="3586085"/>
            <a:chOff x="222423" y="1096827"/>
            <a:chExt cx="5825927" cy="3586085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F50B6F7F-8D21-F049-AF3F-84847A0F1D09}"/>
                </a:ext>
              </a:extLst>
            </p:cNvPr>
            <p:cNvSpPr txBox="1"/>
            <p:nvPr/>
          </p:nvSpPr>
          <p:spPr>
            <a:xfrm>
              <a:off x="2943461" y="4282802"/>
              <a:ext cx="34038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>
                  <a:latin typeface="Times" pitchFamily="2" charset="0"/>
                </a:rPr>
                <a:t>a</a:t>
              </a:r>
            </a:p>
          </p:txBody>
        </p:sp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6B3D84C6-0D1F-8846-9F05-D4C621D2464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b="14844"/>
            <a:stretch/>
          </p:blipFill>
          <p:spPr>
            <a:xfrm>
              <a:off x="222423" y="1096827"/>
              <a:ext cx="5782464" cy="2754738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FEE00B03-599E-3D40-8EA1-DD912FCB66AD}"/>
                </a:ext>
              </a:extLst>
            </p:cNvPr>
            <p:cNvSpPr txBox="1"/>
            <p:nvPr/>
          </p:nvSpPr>
          <p:spPr>
            <a:xfrm>
              <a:off x="831272" y="3762469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1000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FA75A280-3C49-764B-B1A2-7EA8906E715C}"/>
                </a:ext>
              </a:extLst>
            </p:cNvPr>
            <p:cNvSpPr txBox="1"/>
            <p:nvPr/>
          </p:nvSpPr>
          <p:spPr>
            <a:xfrm>
              <a:off x="1279557" y="3762469"/>
              <a:ext cx="4908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900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B3D0F445-A570-2C4C-8464-500151BC5F92}"/>
                </a:ext>
              </a:extLst>
            </p:cNvPr>
            <p:cNvSpPr txBox="1"/>
            <p:nvPr/>
          </p:nvSpPr>
          <p:spPr>
            <a:xfrm>
              <a:off x="1731821" y="3762469"/>
              <a:ext cx="4908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800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152DAD58-73D1-A041-A7D2-C4CC27954927}"/>
                </a:ext>
              </a:extLst>
            </p:cNvPr>
            <p:cNvSpPr txBox="1"/>
            <p:nvPr/>
          </p:nvSpPr>
          <p:spPr>
            <a:xfrm>
              <a:off x="2161311" y="3762469"/>
              <a:ext cx="4908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700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8DA47966-B107-2E4C-9EE3-C777E913827A}"/>
                </a:ext>
              </a:extLst>
            </p:cNvPr>
            <p:cNvSpPr txBox="1"/>
            <p:nvPr/>
          </p:nvSpPr>
          <p:spPr>
            <a:xfrm>
              <a:off x="2604659" y="3762469"/>
              <a:ext cx="575799" cy="304699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600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7B2E56B1-1EAC-134B-B535-A1ECFA68AF05}"/>
                </a:ext>
              </a:extLst>
            </p:cNvPr>
            <p:cNvSpPr txBox="1"/>
            <p:nvPr/>
          </p:nvSpPr>
          <p:spPr>
            <a:xfrm>
              <a:off x="3075706" y="3762469"/>
              <a:ext cx="4908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500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7A8397EF-38A0-2847-B14C-10DA87AE4BC8}"/>
                </a:ext>
              </a:extLst>
            </p:cNvPr>
            <p:cNvSpPr txBox="1"/>
            <p:nvPr/>
          </p:nvSpPr>
          <p:spPr>
            <a:xfrm>
              <a:off x="3607121" y="3762469"/>
              <a:ext cx="4908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400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FFA60294-315D-E74F-868F-D9D9AE9D92F3}"/>
                </a:ext>
              </a:extLst>
            </p:cNvPr>
            <p:cNvSpPr txBox="1"/>
            <p:nvPr/>
          </p:nvSpPr>
          <p:spPr>
            <a:xfrm>
              <a:off x="4059385" y="3762469"/>
              <a:ext cx="4908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300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ED939667-2AC9-FF4B-AF57-366D82F1F1D8}"/>
                </a:ext>
              </a:extLst>
            </p:cNvPr>
            <p:cNvSpPr txBox="1"/>
            <p:nvPr/>
          </p:nvSpPr>
          <p:spPr>
            <a:xfrm>
              <a:off x="4488875" y="3762469"/>
              <a:ext cx="4908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200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2886DECE-C90A-C642-BAD8-8763563794F8}"/>
                </a:ext>
              </a:extLst>
            </p:cNvPr>
            <p:cNvSpPr txBox="1"/>
            <p:nvPr/>
          </p:nvSpPr>
          <p:spPr>
            <a:xfrm>
              <a:off x="4932223" y="3762469"/>
              <a:ext cx="575799" cy="304699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100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720B9367-D707-B24C-B452-B6CAD4783B92}"/>
                </a:ext>
              </a:extLst>
            </p:cNvPr>
            <p:cNvSpPr txBox="1"/>
            <p:nvPr/>
          </p:nvSpPr>
          <p:spPr>
            <a:xfrm>
              <a:off x="5472551" y="3762469"/>
              <a:ext cx="575799" cy="304699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1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70B7F9F4-D918-3B48-AEB0-1B0CC58403F9}"/>
                </a:ext>
              </a:extLst>
            </p:cNvPr>
            <p:cNvSpPr txBox="1"/>
            <p:nvPr/>
          </p:nvSpPr>
          <p:spPr>
            <a:xfrm>
              <a:off x="1947399" y="3990414"/>
              <a:ext cx="2735044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00" dirty="0">
                  <a:latin typeface="Arial" panose="020B0604020202020204" pitchFamily="34" charset="0"/>
                  <a:cs typeface="Arial" panose="020B0604020202020204" pitchFamily="34" charset="0"/>
                </a:rPr>
                <a:t>Position of Best Site in Sequences</a:t>
              </a:r>
            </a:p>
          </p:txBody>
        </p:sp>
      </p:grpSp>
      <p:grpSp>
        <p:nvGrpSpPr>
          <p:cNvPr id="38" name="Group 37">
            <a:extLst>
              <a:ext uri="{FF2B5EF4-FFF2-40B4-BE49-F238E27FC236}">
                <a16:creationId xmlns:a16="http://schemas.microsoft.com/office/drawing/2014/main" id="{DEB11874-852D-064D-BB05-BDDA225011D0}"/>
              </a:ext>
            </a:extLst>
          </p:cNvPr>
          <p:cNvGrpSpPr/>
          <p:nvPr/>
        </p:nvGrpSpPr>
        <p:grpSpPr>
          <a:xfrm>
            <a:off x="6270238" y="1096825"/>
            <a:ext cx="5782464" cy="3587521"/>
            <a:chOff x="6270238" y="1096825"/>
            <a:chExt cx="5782464" cy="3587521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78B07EAE-557E-D844-8375-9133387C2D2A}"/>
                </a:ext>
              </a:extLst>
            </p:cNvPr>
            <p:cNvSpPr txBox="1"/>
            <p:nvPr/>
          </p:nvSpPr>
          <p:spPr>
            <a:xfrm>
              <a:off x="8991276" y="4284236"/>
              <a:ext cx="34038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>
                  <a:latin typeface="Times" pitchFamily="2" charset="0"/>
                </a:rPr>
                <a:t>b</a:t>
              </a:r>
            </a:p>
          </p:txBody>
        </p:sp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BE6BF11B-EFAA-E44D-8B42-788224E3B07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b="14844"/>
            <a:stretch/>
          </p:blipFill>
          <p:spPr>
            <a:xfrm>
              <a:off x="6270238" y="1096825"/>
              <a:ext cx="5782464" cy="2754739"/>
            </a:xfrm>
            <a:prstGeom prst="rect">
              <a:avLst/>
            </a:prstGeom>
          </p:spPr>
        </p:pic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DDAD2BD6-9DF6-2743-9162-817E582A9D4C}"/>
                </a:ext>
              </a:extLst>
            </p:cNvPr>
            <p:cNvSpPr txBox="1"/>
            <p:nvPr/>
          </p:nvSpPr>
          <p:spPr>
            <a:xfrm>
              <a:off x="6835624" y="3784050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1000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B60B2CD7-14D2-4544-913E-89BB7494B89A}"/>
                </a:ext>
              </a:extLst>
            </p:cNvPr>
            <p:cNvSpPr txBox="1"/>
            <p:nvPr/>
          </p:nvSpPr>
          <p:spPr>
            <a:xfrm>
              <a:off x="7283909" y="3784050"/>
              <a:ext cx="4908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900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64066277-592C-5C47-B27E-41DB37116C72}"/>
                </a:ext>
              </a:extLst>
            </p:cNvPr>
            <p:cNvSpPr txBox="1"/>
            <p:nvPr/>
          </p:nvSpPr>
          <p:spPr>
            <a:xfrm>
              <a:off x="7736173" y="3784050"/>
              <a:ext cx="4908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800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669957FA-B21F-4749-BBE9-AA149AEF4781}"/>
                </a:ext>
              </a:extLst>
            </p:cNvPr>
            <p:cNvSpPr txBox="1"/>
            <p:nvPr/>
          </p:nvSpPr>
          <p:spPr>
            <a:xfrm>
              <a:off x="8165663" y="3784050"/>
              <a:ext cx="4908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700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5343AF7B-AC1B-7447-9734-5BAFDD4F9D96}"/>
                </a:ext>
              </a:extLst>
            </p:cNvPr>
            <p:cNvSpPr txBox="1"/>
            <p:nvPr/>
          </p:nvSpPr>
          <p:spPr>
            <a:xfrm>
              <a:off x="8609011" y="3784050"/>
              <a:ext cx="575799" cy="304699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600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D462329C-1112-9A4D-B971-261162442BCE}"/>
                </a:ext>
              </a:extLst>
            </p:cNvPr>
            <p:cNvSpPr txBox="1"/>
            <p:nvPr/>
          </p:nvSpPr>
          <p:spPr>
            <a:xfrm>
              <a:off x="9080058" y="3784050"/>
              <a:ext cx="4908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500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C49C16F0-0E48-E346-8D0E-B8BE6A903EA8}"/>
                </a:ext>
              </a:extLst>
            </p:cNvPr>
            <p:cNvSpPr txBox="1"/>
            <p:nvPr/>
          </p:nvSpPr>
          <p:spPr>
            <a:xfrm>
              <a:off x="9611473" y="3784050"/>
              <a:ext cx="4908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400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D4B883CD-3214-2340-9735-79900C54BA61}"/>
                </a:ext>
              </a:extLst>
            </p:cNvPr>
            <p:cNvSpPr txBox="1"/>
            <p:nvPr/>
          </p:nvSpPr>
          <p:spPr>
            <a:xfrm>
              <a:off x="10063737" y="3784050"/>
              <a:ext cx="4908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300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6596EA3E-F1F6-724D-9542-73750CFD4F33}"/>
                </a:ext>
              </a:extLst>
            </p:cNvPr>
            <p:cNvSpPr txBox="1"/>
            <p:nvPr/>
          </p:nvSpPr>
          <p:spPr>
            <a:xfrm>
              <a:off x="10493227" y="3784050"/>
              <a:ext cx="4908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200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12856AE9-EC99-FD4E-A15C-0F1C8899D24E}"/>
                </a:ext>
              </a:extLst>
            </p:cNvPr>
            <p:cNvSpPr txBox="1"/>
            <p:nvPr/>
          </p:nvSpPr>
          <p:spPr>
            <a:xfrm>
              <a:off x="10936575" y="3784050"/>
              <a:ext cx="575799" cy="304699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100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96B1CC15-87A5-374D-8832-B7C56616E09F}"/>
                </a:ext>
              </a:extLst>
            </p:cNvPr>
            <p:cNvSpPr txBox="1"/>
            <p:nvPr/>
          </p:nvSpPr>
          <p:spPr>
            <a:xfrm>
              <a:off x="11476903" y="3784050"/>
              <a:ext cx="575799" cy="304699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1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86E7F765-648B-2B44-BC7A-B7A33A074AAF}"/>
                </a:ext>
              </a:extLst>
            </p:cNvPr>
            <p:cNvSpPr txBox="1"/>
            <p:nvPr/>
          </p:nvSpPr>
          <p:spPr>
            <a:xfrm>
              <a:off x="7951751" y="4011995"/>
              <a:ext cx="2735044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00" dirty="0">
                  <a:latin typeface="Arial" panose="020B0604020202020204" pitchFamily="34" charset="0"/>
                  <a:cs typeface="Arial" panose="020B0604020202020204" pitchFamily="34" charset="0"/>
                </a:rPr>
                <a:t>Position of Best Site in Sequences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0988055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60</TotalTime>
  <Words>121</Words>
  <Application>Microsoft Macintosh PowerPoint</Application>
  <PresentationFormat>Widescreen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Reddy,Anireddy</cp:lastModifiedBy>
  <cp:revision>20</cp:revision>
  <dcterms:created xsi:type="dcterms:W3CDTF">2019-09-27T18:03:41Z</dcterms:created>
  <dcterms:modified xsi:type="dcterms:W3CDTF">2019-10-31T15:06:42Z</dcterms:modified>
</cp:coreProperties>
</file>